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2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0A7E7B-44AC-231A-26B9-D07131DD5D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6AE6C6D-9A56-BCF8-4AC7-8D16B84864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27DC1FF-6583-2E48-5542-534D14422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0B4CC8F-09A4-F60B-7578-7A1B726A4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F84568B-474A-6524-4FC7-4B8EFEE65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9945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D8A9491-65EF-B946-9DF0-932C5B3DE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BD6210A-CC71-1621-850B-494E2EE3EC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30ECC7C-10E0-9D55-60BE-5F3E4FF18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0657DAC-9394-18DA-49A2-6FE937A81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79CF377-3D3C-CCE2-FF98-7E22D5DF8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9445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6CB89C3C-DC03-3883-A82C-8FBA0F352DC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00FA12E-94DD-63E5-D7C0-7305DEA8C7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3EF63C-F083-5E6C-ED0F-AF7B4E376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681F83B-B9AA-E02F-FAC7-50B68EA9B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0AA6FA2-6135-0403-49DC-7467BD17A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6685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36BA41C-E7AF-2D90-422F-B7FC40C98E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E7B292-57D9-4B08-95BB-B3EC300F0F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AE78D24-FC38-377A-0051-B981BE17C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800AC8B-2A88-03F3-C17D-38E2EFED5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B6DFBD1-65F1-9B72-4820-C3D4133C7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64522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D791D6C-355F-386E-F056-4C7CB5D1D6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1F7056E-7E28-01C4-78A5-8CF34C4AAD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E39D348-EB98-19EE-24AF-672B498FC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D3E4C4D-8557-0184-C7D0-E73139B9B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304498B-91D5-C0C4-2735-274472042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8291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A79777-5672-E076-05A6-76361ACEFC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D5A7598-23FA-8B1D-AB94-C019888BBC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F4FD176-645A-E3A7-BFC8-08DD0FB67C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0C1D7AA-49D6-CBE5-23D5-4280713F0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CF4762-10D1-2648-8923-2AB548B01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3A156FD-DF4D-E74D-C3AA-056952696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50043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26F45D5-6023-332E-662E-9EB5DA18AC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B80E511-3ED8-CDC5-57C8-38E4B745A3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D5CDBE7-2491-60AB-16D8-BB580F4FF6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7132F08-0D3A-8B6F-58B1-0C65D8531B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3D7B2BE6-04CC-8B9A-4FDE-BC1DC7F189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1A408A0-15CE-EC0F-D695-CEAE1BDC6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6531F66-A185-466A-F239-44530A423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84840A1-D4B7-3751-9BFB-323224A58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8193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0FCF08D-400F-DC45-61B9-9AEFA4C4BA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BFFB909B-515B-635D-5279-0EC86E94C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66A739E-132B-8F5A-C587-E8F54598D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EADBF47-9D26-6E83-0B14-070CE3768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8270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589B92C-0F06-AA2B-A95C-E7A366BA9A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333367CF-9DD3-1B0C-66CA-C211279EA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E8D44E8-5124-2A9E-E5F5-52BCB2725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1155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E169F7-F2B6-9B84-474E-D3BB58FD36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62F3700-3F7E-D1C5-1D33-B2B7FC5A03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2CDA9F3-F722-0D6D-B9AE-F7D6412BA5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85EA455-AA2F-6EDC-8D2A-D4B1C30F9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9A28E40-1AD4-024A-6085-1611FA2ED4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24FFE78-032B-28CB-1F67-1D4A84E8A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4780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EDD06F5-2613-A18F-16D8-E118884670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FB34E3F-D51B-7ABC-14FF-CB6C8C3DB1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58851CA-F7CA-8E9B-69B8-DAB54ECF8E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0058B85-B7E0-2DFE-9FE1-418B2BDE6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C268196-F543-2ED8-F7AE-F8DADF893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45D3E0E-38BE-005E-4931-E52920A14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7362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A5D9ECB6-3AFE-B55F-69A7-5A590C6B0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D4AD9A6-C89A-9007-33BD-67EB9E2D61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F374B9F-E4B5-A6FC-8644-52B14B48B2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BE38C-DAAE-4369-9931-9D7C02156123}" type="datetimeFigureOut">
              <a:rPr lang="ko-KR" altLang="en-US" smtClean="0"/>
              <a:t>2023-07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A5C18CB-0316-7D20-DAE2-C583F7A51E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B1DEAD7-68C4-C5F3-F552-D92454C6B7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D9746F-D7D4-44CD-A184-C11CE99389C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4068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8DC510DE-3FD3-1EEB-1275-EF1F1331F4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883" y="1156931"/>
            <a:ext cx="4620270" cy="431542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D4C1EAD-4325-13D1-402A-3462D51146F1}"/>
              </a:ext>
            </a:extLst>
          </p:cNvPr>
          <p:cNvSpPr txBox="1"/>
          <p:nvPr/>
        </p:nvSpPr>
        <p:spPr>
          <a:xfrm>
            <a:off x="8641152" y="713827"/>
            <a:ext cx="107099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/>
              <a:t>Without </a:t>
            </a:r>
          </a:p>
          <a:p>
            <a:pPr algn="ctr"/>
            <a:r>
              <a:rPr lang="en-US" altLang="ko-KR" sz="1400" dirty="0"/>
              <a:t>latecomers</a:t>
            </a:r>
          </a:p>
          <a:p>
            <a:pPr algn="ctr"/>
            <a:r>
              <a:rPr lang="en-US" altLang="ko-KR" sz="1400" dirty="0"/>
              <a:t>n=13 </a:t>
            </a:r>
            <a:endParaRPr lang="ko-KR" altLang="en-US" sz="14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A4CD3DA-A976-12B0-0C7A-13810C7C2EB2}"/>
              </a:ext>
            </a:extLst>
          </p:cNvPr>
          <p:cNvSpPr txBox="1"/>
          <p:nvPr/>
        </p:nvSpPr>
        <p:spPr>
          <a:xfrm>
            <a:off x="10243529" y="713827"/>
            <a:ext cx="1070999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/>
              <a:t>With </a:t>
            </a:r>
          </a:p>
          <a:p>
            <a:pPr algn="ctr"/>
            <a:r>
              <a:rPr lang="en-US" altLang="ko-KR" sz="1400" dirty="0"/>
              <a:t>latecomers</a:t>
            </a:r>
          </a:p>
          <a:p>
            <a:pPr algn="ctr"/>
            <a:r>
              <a:rPr lang="en-US" altLang="ko-KR" sz="1400" dirty="0"/>
              <a:t>n=15 </a:t>
            </a:r>
            <a:endParaRPr lang="ko-KR" altLang="en-US" sz="14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ED82F53-8800-2F76-771F-82B886FDE638}"/>
              </a:ext>
            </a:extLst>
          </p:cNvPr>
          <p:cNvSpPr txBox="1"/>
          <p:nvPr/>
        </p:nvSpPr>
        <p:spPr>
          <a:xfrm>
            <a:off x="5028079" y="1637211"/>
            <a:ext cx="11256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Nationality</a:t>
            </a:r>
            <a:endParaRPr lang="ko-KR" altLang="en-US" sz="1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2B05EF5-DA48-8CBD-0903-4993F1A09B71}"/>
              </a:ext>
            </a:extLst>
          </p:cNvPr>
          <p:cNvSpPr txBox="1"/>
          <p:nvPr/>
        </p:nvSpPr>
        <p:spPr>
          <a:xfrm>
            <a:off x="5028079" y="2991782"/>
            <a:ext cx="22262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Route of administration</a:t>
            </a:r>
            <a:endParaRPr lang="ko-KR" altLang="en-US" sz="1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DCED917-B904-5679-B76A-B49855B28FFA}"/>
              </a:ext>
            </a:extLst>
          </p:cNvPr>
          <p:cNvSpPr txBox="1"/>
          <p:nvPr/>
        </p:nvSpPr>
        <p:spPr>
          <a:xfrm>
            <a:off x="5028079" y="4228404"/>
            <a:ext cx="18959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Number of generics</a:t>
            </a:r>
            <a:endParaRPr lang="ko-KR" altLang="en-US" sz="14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39584A-CC72-3DBD-B60D-48257D52A6BF}"/>
              </a:ext>
            </a:extLst>
          </p:cNvPr>
          <p:cNvSpPr txBox="1"/>
          <p:nvPr/>
        </p:nvSpPr>
        <p:spPr>
          <a:xfrm>
            <a:off x="5309610" y="2153770"/>
            <a:ext cx="26908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Domestic manufacturer (n=15)</a:t>
            </a:r>
            <a:endParaRPr lang="ko-KR" altLang="en-US" sz="14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68CF92B-76E4-C2BF-D73D-640B1E32D8C2}"/>
              </a:ext>
            </a:extLst>
          </p:cNvPr>
          <p:cNvSpPr txBox="1"/>
          <p:nvPr/>
        </p:nvSpPr>
        <p:spPr>
          <a:xfrm>
            <a:off x="5309610" y="2558718"/>
            <a:ext cx="2663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Overseas manufacturer (n=13)</a:t>
            </a:r>
            <a:endParaRPr lang="ko-KR" altLang="en-US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AF62DD2-99A8-76EE-E3BF-C81B9E146809}"/>
              </a:ext>
            </a:extLst>
          </p:cNvPr>
          <p:cNvSpPr txBox="1"/>
          <p:nvPr/>
        </p:nvSpPr>
        <p:spPr>
          <a:xfrm>
            <a:off x="5309610" y="3396730"/>
            <a:ext cx="16526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Oral forms (n=18)</a:t>
            </a:r>
            <a:endParaRPr lang="ko-KR" altLang="en-US"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59B3F00-DA5A-3E33-1406-C19FE09A9E39}"/>
              </a:ext>
            </a:extLst>
          </p:cNvPr>
          <p:cNvSpPr txBox="1"/>
          <p:nvPr/>
        </p:nvSpPr>
        <p:spPr>
          <a:xfrm>
            <a:off x="5309610" y="3801678"/>
            <a:ext cx="1777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Other forms (n=10)</a:t>
            </a:r>
            <a:endParaRPr lang="ko-KR" altLang="en-US" sz="14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E49D53D-770A-0BA3-F6A4-7F8D617EB1ED}"/>
              </a:ext>
            </a:extLst>
          </p:cNvPr>
          <p:cNvSpPr txBox="1"/>
          <p:nvPr/>
        </p:nvSpPr>
        <p:spPr>
          <a:xfrm>
            <a:off x="5309610" y="4655130"/>
            <a:ext cx="25806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Five or fewer generics (n=17)</a:t>
            </a:r>
            <a:endParaRPr lang="ko-KR" altLang="en-US" sz="1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D6E71B0-6492-8021-9D1E-91E8A46C8FDA}"/>
              </a:ext>
            </a:extLst>
          </p:cNvPr>
          <p:cNvSpPr txBox="1"/>
          <p:nvPr/>
        </p:nvSpPr>
        <p:spPr>
          <a:xfrm>
            <a:off x="5309610" y="5060078"/>
            <a:ext cx="24580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Six of more generics (n=10)</a:t>
            </a:r>
            <a:endParaRPr lang="ko-KR" altLang="en-US" sz="14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935510C-FE33-025B-58D5-96A81517390D}"/>
              </a:ext>
            </a:extLst>
          </p:cNvPr>
          <p:cNvSpPr txBox="1"/>
          <p:nvPr/>
        </p:nvSpPr>
        <p:spPr>
          <a:xfrm>
            <a:off x="7880478" y="1581498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Bold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6E98D4D1-0446-D9CC-B411-46E0637922A6}"/>
              </a:ext>
            </a:extLst>
          </p:cNvPr>
          <p:cNvCxnSpPr>
            <a:cxnSpLocks/>
          </p:cNvCxnSpPr>
          <p:nvPr/>
        </p:nvCxnSpPr>
        <p:spPr>
          <a:xfrm flipH="1">
            <a:off x="7419794" y="1791099"/>
            <a:ext cx="304711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CC4C856F-98EB-5740-1FD0-441375E0A81C}"/>
              </a:ext>
            </a:extLst>
          </p:cNvPr>
          <p:cNvSpPr txBox="1"/>
          <p:nvPr/>
        </p:nvSpPr>
        <p:spPr>
          <a:xfrm>
            <a:off x="7880478" y="2937069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Bold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22" name="직선 화살표 연결선 21">
            <a:extLst>
              <a:ext uri="{FF2B5EF4-FFF2-40B4-BE49-F238E27FC236}">
                <a16:creationId xmlns:a16="http://schemas.microsoft.com/office/drawing/2014/main" id="{606E6C51-D2B2-75DD-EA2F-9C708D78B397}"/>
              </a:ext>
            </a:extLst>
          </p:cNvPr>
          <p:cNvCxnSpPr>
            <a:cxnSpLocks/>
          </p:cNvCxnSpPr>
          <p:nvPr/>
        </p:nvCxnSpPr>
        <p:spPr>
          <a:xfrm flipH="1">
            <a:off x="7419794" y="3146670"/>
            <a:ext cx="304711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16E6BAC7-4E98-0F79-E028-2470359503E5}"/>
              </a:ext>
            </a:extLst>
          </p:cNvPr>
          <p:cNvSpPr txBox="1"/>
          <p:nvPr/>
        </p:nvSpPr>
        <p:spPr>
          <a:xfrm>
            <a:off x="7880478" y="4188627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Bold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24" name="직선 화살표 연결선 23">
            <a:extLst>
              <a:ext uri="{FF2B5EF4-FFF2-40B4-BE49-F238E27FC236}">
                <a16:creationId xmlns:a16="http://schemas.microsoft.com/office/drawing/2014/main" id="{BB160012-99FC-27D8-738D-F7A524234C27}"/>
              </a:ext>
            </a:extLst>
          </p:cNvPr>
          <p:cNvCxnSpPr>
            <a:cxnSpLocks/>
          </p:cNvCxnSpPr>
          <p:nvPr/>
        </p:nvCxnSpPr>
        <p:spPr>
          <a:xfrm flipH="1">
            <a:off x="7419794" y="4398228"/>
            <a:ext cx="304711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402336B-8BE4-44D4-B75F-ABC08518C3C7}"/>
              </a:ext>
            </a:extLst>
          </p:cNvPr>
          <p:cNvSpPr txBox="1"/>
          <p:nvPr/>
        </p:nvSpPr>
        <p:spPr>
          <a:xfrm>
            <a:off x="6206051" y="5942304"/>
            <a:ext cx="2196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Make just one line!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079E73D-50FF-D822-E988-60BEF68729DE}"/>
              </a:ext>
            </a:extLst>
          </p:cNvPr>
          <p:cNvSpPr txBox="1"/>
          <p:nvPr/>
        </p:nvSpPr>
        <p:spPr>
          <a:xfrm>
            <a:off x="3847082" y="5939238"/>
            <a:ext cx="2117696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Make some space!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E507B8DD-0424-A0FC-08BD-2687B87679F0}"/>
              </a:ext>
            </a:extLst>
          </p:cNvPr>
          <p:cNvCxnSpPr>
            <a:stCxn id="26" idx="0"/>
            <a:endCxn id="15" idx="1"/>
          </p:cNvCxnSpPr>
          <p:nvPr/>
        </p:nvCxnSpPr>
        <p:spPr>
          <a:xfrm flipV="1">
            <a:off x="4905930" y="4809019"/>
            <a:ext cx="403680" cy="113021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1A95D949-F9D2-77C5-C63F-20FF7FFBB79A}"/>
              </a:ext>
            </a:extLst>
          </p:cNvPr>
          <p:cNvCxnSpPr/>
          <p:nvPr/>
        </p:nvCxnSpPr>
        <p:spPr>
          <a:xfrm flipH="1" flipV="1">
            <a:off x="6818811" y="5367855"/>
            <a:ext cx="435518" cy="44166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94BE9396-ADF4-F4DB-CDD7-5ADFCDF326E2}"/>
              </a:ext>
            </a:extLst>
          </p:cNvPr>
          <p:cNvCxnSpPr/>
          <p:nvPr/>
        </p:nvCxnSpPr>
        <p:spPr>
          <a:xfrm>
            <a:off x="5381897" y="1944988"/>
            <a:ext cx="0" cy="36436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B91692CC-9535-BC2A-6A10-F124321BB936}"/>
              </a:ext>
            </a:extLst>
          </p:cNvPr>
          <p:cNvSpPr txBox="1"/>
          <p:nvPr/>
        </p:nvSpPr>
        <p:spPr>
          <a:xfrm>
            <a:off x="4832381" y="845042"/>
            <a:ext cx="29570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Three</a:t>
            </a:r>
            <a:r>
              <a:rPr lang="ko-KR" altLang="en-US" dirty="0">
                <a:solidFill>
                  <a:srgbClr val="FF0000"/>
                </a:solidFill>
              </a:rPr>
              <a:t> </a:t>
            </a:r>
            <a:r>
              <a:rPr lang="en-US" altLang="ko-KR" dirty="0">
                <a:solidFill>
                  <a:srgbClr val="FF0000"/>
                </a:solidFill>
              </a:rPr>
              <a:t>lines instead of two.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29" name="직선 화살표 연결선 28">
            <a:extLst>
              <a:ext uri="{FF2B5EF4-FFF2-40B4-BE49-F238E27FC236}">
                <a16:creationId xmlns:a16="http://schemas.microsoft.com/office/drawing/2014/main" id="{E79745EE-78B7-4621-63C5-311C774E41C2}"/>
              </a:ext>
            </a:extLst>
          </p:cNvPr>
          <p:cNvCxnSpPr/>
          <p:nvPr/>
        </p:nvCxnSpPr>
        <p:spPr>
          <a:xfrm>
            <a:off x="8000411" y="1048484"/>
            <a:ext cx="498883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695980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CA582A53-B73B-1C2B-5836-8CEC0423AB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941" y="850799"/>
            <a:ext cx="12044059" cy="515640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F65AB71-9DB1-CBBE-1E0F-04D6A93DDD20}"/>
              </a:ext>
            </a:extLst>
          </p:cNvPr>
          <p:cNvSpPr txBox="1"/>
          <p:nvPr/>
        </p:nvSpPr>
        <p:spPr>
          <a:xfrm>
            <a:off x="1838740" y="2445026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solidFill>
                  <a:srgbClr val="FF0000"/>
                </a:solidFill>
              </a:rPr>
              <a:t>Bold</a:t>
            </a:r>
            <a:endParaRPr lang="ko-KR" altLang="en-US" b="1" dirty="0">
              <a:solidFill>
                <a:srgbClr val="FF0000"/>
              </a:solidFill>
            </a:endParaRPr>
          </a:p>
        </p:txBody>
      </p:sp>
      <p:cxnSp>
        <p:nvCxnSpPr>
          <p:cNvPr id="8" name="직선 화살표 연결선 7">
            <a:extLst>
              <a:ext uri="{FF2B5EF4-FFF2-40B4-BE49-F238E27FC236}">
                <a16:creationId xmlns:a16="http://schemas.microsoft.com/office/drawing/2014/main" id="{A32A6CDC-B21E-468D-CF51-912D43CD89CF}"/>
              </a:ext>
            </a:extLst>
          </p:cNvPr>
          <p:cNvCxnSpPr/>
          <p:nvPr/>
        </p:nvCxnSpPr>
        <p:spPr>
          <a:xfrm flipH="1">
            <a:off x="1302026" y="2633870"/>
            <a:ext cx="447261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F10E56D4-4F86-A191-2487-6836F4FA2B60}"/>
              </a:ext>
            </a:extLst>
          </p:cNvPr>
          <p:cNvSpPr txBox="1"/>
          <p:nvPr/>
        </p:nvSpPr>
        <p:spPr>
          <a:xfrm>
            <a:off x="2596386" y="3507471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solidFill>
                  <a:srgbClr val="FF0000"/>
                </a:solidFill>
              </a:rPr>
              <a:t>Bold</a:t>
            </a:r>
            <a:endParaRPr lang="ko-KR" altLang="en-US" b="1" dirty="0">
              <a:solidFill>
                <a:srgbClr val="FF0000"/>
              </a:solidFill>
            </a:endParaRPr>
          </a:p>
        </p:txBody>
      </p:sp>
      <p:cxnSp>
        <p:nvCxnSpPr>
          <p:cNvPr id="10" name="직선 화살표 연결선 9">
            <a:extLst>
              <a:ext uri="{FF2B5EF4-FFF2-40B4-BE49-F238E27FC236}">
                <a16:creationId xmlns:a16="http://schemas.microsoft.com/office/drawing/2014/main" id="{F6EF14D0-70EB-6113-E0A7-4C20294EA86E}"/>
              </a:ext>
            </a:extLst>
          </p:cNvPr>
          <p:cNvCxnSpPr/>
          <p:nvPr/>
        </p:nvCxnSpPr>
        <p:spPr>
          <a:xfrm flipH="1">
            <a:off x="2059672" y="3696315"/>
            <a:ext cx="447261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0D0DAB94-4700-5730-FC24-E4286BDBA7D2}"/>
              </a:ext>
            </a:extLst>
          </p:cNvPr>
          <p:cNvSpPr txBox="1"/>
          <p:nvPr/>
        </p:nvSpPr>
        <p:spPr>
          <a:xfrm>
            <a:off x="2439629" y="4568491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solidFill>
                  <a:srgbClr val="FF0000"/>
                </a:solidFill>
              </a:rPr>
              <a:t>Bold</a:t>
            </a:r>
            <a:endParaRPr lang="ko-KR" altLang="en-US" b="1" dirty="0">
              <a:solidFill>
                <a:srgbClr val="FF0000"/>
              </a:solidFill>
            </a:endParaRPr>
          </a:p>
        </p:txBody>
      </p:sp>
      <p:cxnSp>
        <p:nvCxnSpPr>
          <p:cNvPr id="15" name="직선 화살표 연결선 14">
            <a:extLst>
              <a:ext uri="{FF2B5EF4-FFF2-40B4-BE49-F238E27FC236}">
                <a16:creationId xmlns:a16="http://schemas.microsoft.com/office/drawing/2014/main" id="{6F9632F2-F320-AAFF-A73B-84018D815D1C}"/>
              </a:ext>
            </a:extLst>
          </p:cNvPr>
          <p:cNvCxnSpPr/>
          <p:nvPr/>
        </p:nvCxnSpPr>
        <p:spPr>
          <a:xfrm flipH="1">
            <a:off x="1902915" y="4757335"/>
            <a:ext cx="447261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1B84EF3-B56E-3287-D946-AA14F766C5FE}"/>
              </a:ext>
            </a:extLst>
          </p:cNvPr>
          <p:cNvSpPr txBox="1"/>
          <p:nvPr/>
        </p:nvSpPr>
        <p:spPr>
          <a:xfrm>
            <a:off x="2656249" y="1339742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chemeClr val="bg1"/>
                </a:solidFill>
              </a:rPr>
              <a:t>All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057BDA-769A-E4A8-64F6-7386E6BD9C43}"/>
              </a:ext>
            </a:extLst>
          </p:cNvPr>
          <p:cNvSpPr txBox="1"/>
          <p:nvPr/>
        </p:nvSpPr>
        <p:spPr>
          <a:xfrm>
            <a:off x="3709987" y="1339742"/>
            <a:ext cx="22410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chemeClr val="bg1"/>
                </a:solidFill>
              </a:rPr>
              <a:t>Without latecomers</a:t>
            </a:r>
            <a:endParaRPr lang="ko-KR" altLang="en-US" dirty="0">
              <a:solidFill>
                <a:schemeClr val="bg1"/>
              </a:solidFill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B91A67C5-D232-DD9B-7796-9437A3A75069}"/>
              </a:ext>
            </a:extLst>
          </p:cNvPr>
          <p:cNvCxnSpPr/>
          <p:nvPr/>
        </p:nvCxnSpPr>
        <p:spPr>
          <a:xfrm>
            <a:off x="2596386" y="1889759"/>
            <a:ext cx="50902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A8FC3C4F-85F5-2643-FCB1-F41CC240B5D9}"/>
              </a:ext>
            </a:extLst>
          </p:cNvPr>
          <p:cNvCxnSpPr/>
          <p:nvPr/>
        </p:nvCxnSpPr>
        <p:spPr>
          <a:xfrm>
            <a:off x="2596386" y="1950719"/>
            <a:ext cx="50902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>
            <a:extLst>
              <a:ext uri="{FF2B5EF4-FFF2-40B4-BE49-F238E27FC236}">
                <a16:creationId xmlns:a16="http://schemas.microsoft.com/office/drawing/2014/main" id="{44CC8BC1-8ECC-7D14-FAC4-5858B0AB8C0B}"/>
              </a:ext>
            </a:extLst>
          </p:cNvPr>
          <p:cNvCxnSpPr>
            <a:cxnSpLocks/>
          </p:cNvCxnSpPr>
          <p:nvPr/>
        </p:nvCxnSpPr>
        <p:spPr>
          <a:xfrm>
            <a:off x="3867838" y="1889759"/>
            <a:ext cx="1984322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F17C6C0F-2F6F-0BEC-0D70-B3C773BFAC4D}"/>
              </a:ext>
            </a:extLst>
          </p:cNvPr>
          <p:cNvCxnSpPr>
            <a:cxnSpLocks/>
          </p:cNvCxnSpPr>
          <p:nvPr/>
        </p:nvCxnSpPr>
        <p:spPr>
          <a:xfrm>
            <a:off x="3867838" y="1950719"/>
            <a:ext cx="194948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F22E1800-E35C-93C8-4CD7-4006767D92AD}"/>
              </a:ext>
            </a:extLst>
          </p:cNvPr>
          <p:cNvSpPr txBox="1"/>
          <p:nvPr/>
        </p:nvSpPr>
        <p:spPr>
          <a:xfrm>
            <a:off x="312118" y="173297"/>
            <a:ext cx="2427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Move to the first row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29" name="직선 화살표 연결선 28">
            <a:extLst>
              <a:ext uri="{FF2B5EF4-FFF2-40B4-BE49-F238E27FC236}">
                <a16:creationId xmlns:a16="http://schemas.microsoft.com/office/drawing/2014/main" id="{CE0592A9-6621-7720-FDCB-EA49B22E3F1D}"/>
              </a:ext>
            </a:extLst>
          </p:cNvPr>
          <p:cNvCxnSpPr>
            <a:cxnSpLocks/>
          </p:cNvCxnSpPr>
          <p:nvPr/>
        </p:nvCxnSpPr>
        <p:spPr>
          <a:xfrm>
            <a:off x="2937986" y="502049"/>
            <a:ext cx="0" cy="91744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5F99D391-E6DE-0398-D802-9165B194B084}"/>
              </a:ext>
            </a:extLst>
          </p:cNvPr>
          <p:cNvCxnSpPr>
            <a:endCxn id="17" idx="0"/>
          </p:cNvCxnSpPr>
          <p:nvPr/>
        </p:nvCxnSpPr>
        <p:spPr>
          <a:xfrm>
            <a:off x="2937986" y="478971"/>
            <a:ext cx="1892533" cy="86077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512780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92</Words>
  <Application>Microsoft Office PowerPoint</Application>
  <PresentationFormat>와이드스크린</PresentationFormat>
  <Paragraphs>27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nkyungbok</dc:creator>
  <cp:lastModifiedBy>sonkyungbok</cp:lastModifiedBy>
  <cp:revision>2</cp:revision>
  <dcterms:created xsi:type="dcterms:W3CDTF">2023-07-22T02:17:22Z</dcterms:created>
  <dcterms:modified xsi:type="dcterms:W3CDTF">2023-07-22T08:47:18Z</dcterms:modified>
</cp:coreProperties>
</file>